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ags/tag2.xml" ContentType="application/vnd.openxmlformats-officedocument.presentationml.tags+xml"/>
  <Override PartName="/ppt/theme/theme2.xml" ContentType="application/vnd.openxmlformats-officedocument.theme+xml"/>
  <Override PartName="/ppt/tags/tag3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hibaud André" initials="Tx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112" autoAdjust="0"/>
  </p:normalViewPr>
  <p:slideViewPr>
    <p:cSldViewPr>
      <p:cViewPr varScale="1">
        <p:scale>
          <a:sx n="72" d="100"/>
          <a:sy n="72" d="100"/>
        </p:scale>
        <p:origin x="1320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C78C44-967C-4C13-8419-C6A08564CA03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0AB944-787F-41D0-AB8C-543AE5CE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572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Original</a:t>
            </a:r>
            <a:r>
              <a:rPr lang="en-US" baseline="0"/>
              <a:t> colors of the logo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D64F-883D-4262-97B6-3B10F27BEB2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2623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3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262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2655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18977-94FB-415F-B497-03350E8854FC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3"/>
          </p:nvPr>
        </p:nvSpPr>
        <p:spPr>
          <a:xfrm>
            <a:off x="392907" y="666184"/>
            <a:ext cx="7419454" cy="417287"/>
          </a:xfrm>
        </p:spPr>
        <p:txBody>
          <a:bodyPr/>
          <a:lstStyle>
            <a:lvl1pPr marL="0" indent="0">
              <a:buNone/>
              <a:defRPr sz="1800">
                <a:latin typeface="+mj-lt"/>
              </a:defRPr>
            </a:lvl1pPr>
            <a:lvl2pPr marL="358775" indent="0">
              <a:buNone/>
              <a:defRPr>
                <a:latin typeface="Cambria" pitchFamily="18" charset="0"/>
              </a:defRPr>
            </a:lvl2pPr>
            <a:lvl3pPr marL="717550" indent="0">
              <a:buNone/>
              <a:defRPr>
                <a:latin typeface="Cambria" pitchFamily="18" charset="0"/>
              </a:defRPr>
            </a:lvl3pPr>
            <a:lvl4pPr marL="1076325" indent="0">
              <a:buNone/>
              <a:defRPr>
                <a:latin typeface="Cambria" pitchFamily="18" charset="0"/>
              </a:defRPr>
            </a:lvl4pPr>
            <a:lvl5pPr marL="1435100" indent="0">
              <a:buNone/>
              <a:defRPr>
                <a:latin typeface="Cambria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2"/>
          </p:nvPr>
        </p:nvSpPr>
        <p:spPr>
          <a:xfrm>
            <a:off x="1710428" y="6476210"/>
            <a:ext cx="917863" cy="365125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00 Month 0000</a:t>
            </a:r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5288" y="6476210"/>
            <a:ext cx="1315139" cy="365125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Presentation title in footer</a:t>
            </a:r>
          </a:p>
        </p:txBody>
      </p:sp>
    </p:spTree>
    <p:extLst>
      <p:ext uri="{BB962C8B-B14F-4D97-AF65-F5344CB8AC3E}">
        <p14:creationId xmlns:p14="http://schemas.microsoft.com/office/powerpoint/2010/main" val="3580290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476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041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7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076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627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043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898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439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2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vmlDrawing" Target="../drawings/vmlDrawing1.v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 hidden="1"/>
          <p:cNvGraphicFramePr>
            <a:graphicFrameLocks noChangeAspect="1"/>
          </p:cNvGraphicFramePr>
          <p:nvPr userDrawn="1">
            <p:custDataLst>
              <p:tags r:id="rId15"/>
            </p:custDataLst>
            <p:extLst>
              <p:ext uri="{D42A27DB-BD31-4B8C-83A1-F6EECF244321}">
                <p14:modId xmlns:p14="http://schemas.microsoft.com/office/powerpoint/2010/main" val="1720706282"/>
              </p:ext>
            </p:ext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think-cell Slide" r:id="rId16" imgW="270" imgH="270" progId="TCLayout.ActiveDocument.1">
                  <p:embed/>
                </p:oleObj>
              </mc:Choice>
              <mc:Fallback>
                <p:oleObj name="think-cell Slide" r:id="rId16" imgW="270" imgH="270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2C36E-B94A-4C1A-8B18-FD2C401B938F}" type="datetimeFigureOut">
              <a:rPr lang="en-US" smtClean="0"/>
              <a:t>3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3386BD-AC7F-476B-AFF1-F13E2D1C8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198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12.xml"/><Relationship Id="rId7" Type="http://schemas.openxmlformats.org/officeDocument/2006/relationships/image" Target="../media/image2.png"/><Relationship Id="rId2" Type="http://schemas.openxmlformats.org/officeDocument/2006/relationships/tags" Target="../tags/tag3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png"/><Relationship Id="rId4" Type="http://schemas.openxmlformats.org/officeDocument/2006/relationships/notesSlide" Target="../notesSlides/notesSlide1.xml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 hidden="1"/>
          <p:cNvGraphicFramePr>
            <a:graphicFrameLocks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470405846"/>
              </p:ext>
            </p:extLst>
          </p:nvPr>
        </p:nvGraphicFramePr>
        <p:xfrm>
          <a:off x="1589" y="1590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think-cell Slide" r:id="rId5" imgW="270" imgH="270" progId="TCLayout.ActiveDocument.1">
                  <p:embed/>
                </p:oleObj>
              </mc:Choice>
              <mc:Fallback>
                <p:oleObj name="think-cell Slide" r:id="rId5" imgW="270" imgH="270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89" y="1590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76200"/>
            <a:ext cx="2014732" cy="1743460"/>
          </a:xfrm>
          <a:prstGeom prst="rect">
            <a:avLst/>
          </a:prstGeom>
        </p:spPr>
      </p:pic>
      <p:sp>
        <p:nvSpPr>
          <p:cNvPr id="29" name="Rectangle 8"/>
          <p:cNvSpPr/>
          <p:nvPr/>
        </p:nvSpPr>
        <p:spPr>
          <a:xfrm>
            <a:off x="3510767" y="213212"/>
            <a:ext cx="5600884" cy="1469436"/>
          </a:xfrm>
          <a:custGeom>
            <a:avLst/>
            <a:gdLst/>
            <a:ahLst/>
            <a:cxnLst/>
            <a:rect l="l" t="t" r="r" b="b"/>
            <a:pathLst>
              <a:path w="6645351" h="1743460">
                <a:moveTo>
                  <a:pt x="0" y="0"/>
                </a:moveTo>
                <a:lnTo>
                  <a:pt x="6645351" y="0"/>
                </a:lnTo>
                <a:lnTo>
                  <a:pt x="6645351" y="1743460"/>
                </a:lnTo>
                <a:lnTo>
                  <a:pt x="0" y="1743460"/>
                </a:lnTo>
                <a:lnTo>
                  <a:pt x="0" y="1742023"/>
                </a:lnTo>
                <a:lnTo>
                  <a:pt x="33720" y="1742023"/>
                </a:lnTo>
                <a:lnTo>
                  <a:pt x="531005" y="871730"/>
                </a:lnTo>
                <a:lnTo>
                  <a:pt x="33720" y="1437"/>
                </a:lnTo>
                <a:lnTo>
                  <a:pt x="0" y="1437"/>
                </a:lnTo>
                <a:close/>
              </a:path>
            </a:pathLst>
          </a:custGeom>
          <a:solidFill>
            <a:srgbClr val="FF9933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76000" tIns="36000" rIns="36000" bIns="36000" rtlCol="0" anchor="ctr" anchorCtr="0"/>
          <a:lstStyle/>
          <a:p>
            <a:r>
              <a:rPr lang="en-US" sz="4000" b="1" dirty="0"/>
              <a:t>Focus on the Patient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515256" y="3526590"/>
            <a:ext cx="8102748" cy="1539998"/>
            <a:chOff x="515256" y="3533712"/>
            <a:chExt cx="8102748" cy="1539998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5256" y="3533712"/>
              <a:ext cx="1698071" cy="1469436"/>
            </a:xfrm>
            <a:prstGeom prst="rect">
              <a:avLst/>
            </a:prstGeom>
          </p:spPr>
        </p:pic>
        <p:sp>
          <p:nvSpPr>
            <p:cNvPr id="21" name="Oval 20"/>
            <p:cNvSpPr/>
            <p:nvPr/>
          </p:nvSpPr>
          <p:spPr>
            <a:xfrm>
              <a:off x="1828800" y="3615710"/>
              <a:ext cx="6789204" cy="1458000"/>
            </a:xfrm>
            <a:custGeom>
              <a:avLst/>
              <a:gdLst/>
              <a:ahLst/>
              <a:cxnLst/>
              <a:rect l="l" t="t" r="r" b="b"/>
              <a:pathLst>
                <a:path w="6789204" h="1458000">
                  <a:moveTo>
                    <a:pt x="0" y="0"/>
                  </a:moveTo>
                  <a:lnTo>
                    <a:pt x="6060204" y="0"/>
                  </a:lnTo>
                  <a:lnTo>
                    <a:pt x="6060205" y="0"/>
                  </a:lnTo>
                  <a:lnTo>
                    <a:pt x="6060205" y="0"/>
                  </a:lnTo>
                  <a:cubicBezTo>
                    <a:pt x="6462820" y="0"/>
                    <a:pt x="6789204" y="326384"/>
                    <a:pt x="6789204" y="729000"/>
                  </a:cubicBezTo>
                  <a:cubicBezTo>
                    <a:pt x="6789204" y="1131616"/>
                    <a:pt x="6462820" y="1458000"/>
                    <a:pt x="6060205" y="1458000"/>
                  </a:cubicBezTo>
                  <a:lnTo>
                    <a:pt x="6060205" y="1458000"/>
                  </a:lnTo>
                  <a:lnTo>
                    <a:pt x="6060204" y="1458000"/>
                  </a:lnTo>
                  <a:lnTo>
                    <a:pt x="0" y="1458000"/>
                  </a:lnTo>
                  <a:lnTo>
                    <a:pt x="416551" y="729000"/>
                  </a:lnTo>
                  <a:close/>
                </a:path>
              </a:pathLst>
            </a:custGeom>
            <a:noFill/>
            <a:ln w="19050">
              <a:solidFill>
                <a:srgbClr val="FF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576000" rIns="360000" rtlCol="0" anchor="ctr"/>
            <a:lstStyle/>
            <a:p>
              <a:pPr algn="just"/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</a:rPr>
                <a:t>We here provide evidence that the length of influenza seasons and the period of influenza activity varies considerably. Each season is dominated by a subtype which may be IBV. Furthermore, IBV lineage contained in the vaccine (trivalent subunit influenza vaccine – 2A/1B lineages) only matches the lineage in circulation approximately 50% of the time. Thus, these variations show how difficult it is to predict which IBV lineage will dominate in a given season.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757569" y="1846963"/>
            <a:ext cx="8103908" cy="1537458"/>
            <a:chOff x="963892" y="5181425"/>
            <a:chExt cx="8103908" cy="1537458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3892" y="5181425"/>
              <a:ext cx="1698071" cy="1469436"/>
            </a:xfrm>
            <a:prstGeom prst="rect">
              <a:avLst/>
            </a:prstGeom>
          </p:spPr>
        </p:pic>
        <p:sp>
          <p:nvSpPr>
            <p:cNvPr id="41" name="Oval 20"/>
            <p:cNvSpPr/>
            <p:nvPr/>
          </p:nvSpPr>
          <p:spPr>
            <a:xfrm>
              <a:off x="2278596" y="5260883"/>
              <a:ext cx="6789204" cy="1458000"/>
            </a:xfrm>
            <a:custGeom>
              <a:avLst/>
              <a:gdLst/>
              <a:ahLst/>
              <a:cxnLst/>
              <a:rect l="l" t="t" r="r" b="b"/>
              <a:pathLst>
                <a:path w="6789204" h="1458000">
                  <a:moveTo>
                    <a:pt x="0" y="0"/>
                  </a:moveTo>
                  <a:lnTo>
                    <a:pt x="6060204" y="0"/>
                  </a:lnTo>
                  <a:lnTo>
                    <a:pt x="6060205" y="0"/>
                  </a:lnTo>
                  <a:lnTo>
                    <a:pt x="6060205" y="0"/>
                  </a:lnTo>
                  <a:cubicBezTo>
                    <a:pt x="6462820" y="0"/>
                    <a:pt x="6789204" y="326384"/>
                    <a:pt x="6789204" y="729000"/>
                  </a:cubicBezTo>
                  <a:cubicBezTo>
                    <a:pt x="6789204" y="1131616"/>
                    <a:pt x="6462820" y="1458000"/>
                    <a:pt x="6060205" y="1458000"/>
                  </a:cubicBezTo>
                  <a:lnTo>
                    <a:pt x="6060205" y="1458000"/>
                  </a:lnTo>
                  <a:lnTo>
                    <a:pt x="6060204" y="1458000"/>
                  </a:lnTo>
                  <a:lnTo>
                    <a:pt x="0" y="1458000"/>
                  </a:lnTo>
                  <a:lnTo>
                    <a:pt x="416551" y="729000"/>
                  </a:lnTo>
                  <a:close/>
                </a:path>
              </a:pathLst>
            </a:custGeom>
            <a:noFill/>
            <a:ln w="19050">
              <a:solidFill>
                <a:srgbClr val="FF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576000" tIns="36000" rIns="360000" bIns="36000" rtlCol="0" anchor="ctr"/>
            <a:lstStyle/>
            <a:p>
              <a:pPr algn="just"/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</a:rPr>
                <a:t>Seasonal influenza is a public health problem responsible for significant morbidity and mortality worldwide. Seasonal Influenza disease is mainly caused by two subtypes of Influenza A (</a:t>
              </a:r>
              <a:r>
                <a:rPr lang="en-US" sz="1200" b="1" dirty="0" err="1">
                  <a:solidFill>
                    <a:schemeClr val="accent6">
                      <a:lumMod val="75000"/>
                    </a:schemeClr>
                  </a:solidFill>
                </a:rPr>
                <a:t>Influanza</a:t>
              </a:r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</a:rPr>
                <a:t> A/H1 and Influenza A/H3) and two different lineage of Influenza B (Victoria and Yamagata); these two types (A and B) co-circulate seasonally. In this study, we investigated the circulating influenza subtypes/lineages; additionally to duration and timing of peak influenza activity during 13 consecutive Flu seasons (Western Turkey; 2003-2016).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344326" y="5166911"/>
            <a:ext cx="8107682" cy="1478232"/>
            <a:chOff x="963892" y="1939158"/>
            <a:chExt cx="8107682" cy="1478232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3892" y="1947954"/>
              <a:ext cx="1698071" cy="1469436"/>
            </a:xfrm>
            <a:prstGeom prst="rect">
              <a:avLst/>
            </a:prstGeom>
          </p:spPr>
        </p:pic>
        <p:sp>
          <p:nvSpPr>
            <p:cNvPr id="42" name="Oval 20"/>
            <p:cNvSpPr/>
            <p:nvPr/>
          </p:nvSpPr>
          <p:spPr>
            <a:xfrm>
              <a:off x="2282370" y="1939158"/>
              <a:ext cx="6789204" cy="1458000"/>
            </a:xfrm>
            <a:custGeom>
              <a:avLst/>
              <a:gdLst/>
              <a:ahLst/>
              <a:cxnLst/>
              <a:rect l="l" t="t" r="r" b="b"/>
              <a:pathLst>
                <a:path w="6789204" h="1458000">
                  <a:moveTo>
                    <a:pt x="0" y="0"/>
                  </a:moveTo>
                  <a:lnTo>
                    <a:pt x="6060204" y="0"/>
                  </a:lnTo>
                  <a:lnTo>
                    <a:pt x="6060205" y="0"/>
                  </a:lnTo>
                  <a:lnTo>
                    <a:pt x="6060205" y="0"/>
                  </a:lnTo>
                  <a:cubicBezTo>
                    <a:pt x="6462820" y="0"/>
                    <a:pt x="6789204" y="326384"/>
                    <a:pt x="6789204" y="729000"/>
                  </a:cubicBezTo>
                  <a:cubicBezTo>
                    <a:pt x="6789204" y="1131616"/>
                    <a:pt x="6462820" y="1458000"/>
                    <a:pt x="6060205" y="1458000"/>
                  </a:cubicBezTo>
                  <a:lnTo>
                    <a:pt x="6060205" y="1458000"/>
                  </a:lnTo>
                  <a:lnTo>
                    <a:pt x="6060204" y="1458000"/>
                  </a:lnTo>
                  <a:lnTo>
                    <a:pt x="0" y="1458000"/>
                  </a:lnTo>
                  <a:lnTo>
                    <a:pt x="416551" y="729000"/>
                  </a:lnTo>
                  <a:close/>
                </a:path>
              </a:pathLst>
            </a:custGeom>
            <a:noFill/>
            <a:ln w="19050">
              <a:solidFill>
                <a:srgbClr val="FF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576000" rIns="360000" rtlCol="0" anchor="ctr"/>
            <a:lstStyle/>
            <a:p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</a:rPr>
                <a:t>These results have important implications for vaccine composition (IBV lineages): </a:t>
              </a:r>
              <a:r>
                <a:rPr lang="en-US" sz="1200" b="1" dirty="0" err="1">
                  <a:solidFill>
                    <a:schemeClr val="accent6">
                      <a:lumMod val="75000"/>
                    </a:schemeClr>
                  </a:solidFill>
                </a:rPr>
                <a:t>quadrivalent</a:t>
              </a:r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</a:rPr>
                <a:t> vaccines containing both IBV lineages can reduce B-lineage mismatch, thus reducing the burden of IBV disease. Additionally, it gives important information on vaccination timing in order to perform optimal vaccination program. </a:t>
              </a:r>
            </a:p>
          </p:txBody>
        </p:sp>
      </p:grpSp>
      <p:sp>
        <p:nvSpPr>
          <p:cNvPr id="43" name="Rounded Rectangle 42"/>
          <p:cNvSpPr/>
          <p:nvPr/>
        </p:nvSpPr>
        <p:spPr>
          <a:xfrm>
            <a:off x="1670590" y="3477498"/>
            <a:ext cx="3333600" cy="244800"/>
          </a:xfrm>
          <a:prstGeom prst="roundRect">
            <a:avLst>
              <a:gd name="adj" fmla="val 50000"/>
            </a:avLst>
          </a:prstGeom>
          <a:solidFill>
            <a:srgbClr val="FF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000" bIns="36000" rtlCol="0" anchor="ctr" anchorCtr="1"/>
          <a:lstStyle/>
          <a:p>
            <a:pPr algn="ctr"/>
            <a:r>
              <a:rPr lang="en-US" b="1" dirty="0"/>
              <a:t>What is new?</a:t>
            </a:r>
          </a:p>
        </p:txBody>
      </p:sp>
      <p:sp>
        <p:nvSpPr>
          <p:cNvPr id="48" name="Rounded Rectangle 47"/>
          <p:cNvSpPr/>
          <p:nvPr/>
        </p:nvSpPr>
        <p:spPr>
          <a:xfrm>
            <a:off x="1508707" y="5073284"/>
            <a:ext cx="3333884" cy="245310"/>
          </a:xfrm>
          <a:prstGeom prst="roundRect">
            <a:avLst>
              <a:gd name="adj" fmla="val 50000"/>
            </a:avLst>
          </a:prstGeom>
          <a:solidFill>
            <a:srgbClr val="FF6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000" bIns="36000" rtlCol="0" anchor="ctr" anchorCtr="1"/>
          <a:lstStyle/>
          <a:p>
            <a:pPr algn="ctr"/>
            <a:r>
              <a:rPr lang="en-US" b="1" dirty="0"/>
              <a:t>What is the impact?</a:t>
            </a:r>
          </a:p>
        </p:txBody>
      </p:sp>
      <p:sp>
        <p:nvSpPr>
          <p:cNvPr id="49" name="Rounded Rectangle 48"/>
          <p:cNvSpPr/>
          <p:nvPr/>
        </p:nvSpPr>
        <p:spPr>
          <a:xfrm>
            <a:off x="1843967" y="1762262"/>
            <a:ext cx="3333600" cy="245310"/>
          </a:xfrm>
          <a:prstGeom prst="roundRect">
            <a:avLst>
              <a:gd name="adj" fmla="val 50000"/>
            </a:avLst>
          </a:prstGeom>
          <a:solidFill>
            <a:srgbClr val="FF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000" bIns="36000" rtlCol="0" anchor="ctr" anchorCtr="1"/>
          <a:lstStyle/>
          <a:p>
            <a:pPr algn="ctr"/>
            <a:r>
              <a:rPr lang="en-US" b="1" dirty="0"/>
              <a:t>What is the context?</a:t>
            </a:r>
          </a:p>
        </p:txBody>
      </p:sp>
    </p:spTree>
    <p:extLst>
      <p:ext uri="{BB962C8B-B14F-4D97-AF65-F5344CB8AC3E}">
        <p14:creationId xmlns:p14="http://schemas.microsoft.com/office/powerpoint/2010/main" val="41120216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0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mbria</vt:lpstr>
      <vt:lpstr>Office Theme</vt:lpstr>
      <vt:lpstr>think-cell Slide</vt:lpstr>
      <vt:lpstr>PowerPoint Presentation</vt:lpstr>
    </vt:vector>
  </TitlesOfParts>
  <Company>GlaxoSmithKline Biological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ibaud André</dc:creator>
  <cp:lastModifiedBy>Cronk, Allison</cp:lastModifiedBy>
  <cp:revision>21</cp:revision>
  <dcterms:created xsi:type="dcterms:W3CDTF">2017-09-19T09:06:29Z</dcterms:created>
  <dcterms:modified xsi:type="dcterms:W3CDTF">2018-03-19T16:09:30Z</dcterms:modified>
</cp:coreProperties>
</file>